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0" r:id="rId2"/>
    <p:sldId id="256" r:id="rId3"/>
    <p:sldId id="257" r:id="rId4"/>
    <p:sldId id="259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79" d="100"/>
          <a:sy n="79" d="100"/>
        </p:scale>
        <p:origin x="306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45229-A2D6-4703-9BC7-7972F03D81E8}" type="datetimeFigureOut">
              <a:rPr lang="es-ES" smtClean="0"/>
              <a:t>06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16AC64-D458-4E98-B918-6A6BA581F38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986920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45229-A2D6-4703-9BC7-7972F03D81E8}" type="datetimeFigureOut">
              <a:rPr lang="es-ES" smtClean="0"/>
              <a:t>06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16AC64-D458-4E98-B918-6A6BA581F38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770721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45229-A2D6-4703-9BC7-7972F03D81E8}" type="datetimeFigureOut">
              <a:rPr lang="es-ES" smtClean="0"/>
              <a:t>06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16AC64-D458-4E98-B918-6A6BA581F38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945329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45229-A2D6-4703-9BC7-7972F03D81E8}" type="datetimeFigureOut">
              <a:rPr lang="es-ES" smtClean="0"/>
              <a:t>06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16AC64-D458-4E98-B918-6A6BA581F38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665048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45229-A2D6-4703-9BC7-7972F03D81E8}" type="datetimeFigureOut">
              <a:rPr lang="es-ES" smtClean="0"/>
              <a:t>06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16AC64-D458-4E98-B918-6A6BA581F38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09438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45229-A2D6-4703-9BC7-7972F03D81E8}" type="datetimeFigureOut">
              <a:rPr lang="es-ES" smtClean="0"/>
              <a:t>06/04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16AC64-D458-4E98-B918-6A6BA581F38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147576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45229-A2D6-4703-9BC7-7972F03D81E8}" type="datetimeFigureOut">
              <a:rPr lang="es-ES" smtClean="0"/>
              <a:t>06/04/2022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16AC64-D458-4E98-B918-6A6BA581F38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180615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45229-A2D6-4703-9BC7-7972F03D81E8}" type="datetimeFigureOut">
              <a:rPr lang="es-ES" smtClean="0"/>
              <a:t>06/04/2022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16AC64-D458-4E98-B918-6A6BA581F38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978404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45229-A2D6-4703-9BC7-7972F03D81E8}" type="datetimeFigureOut">
              <a:rPr lang="es-ES" smtClean="0"/>
              <a:t>06/04/2022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16AC64-D458-4E98-B918-6A6BA581F38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362762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45229-A2D6-4703-9BC7-7972F03D81E8}" type="datetimeFigureOut">
              <a:rPr lang="es-ES" smtClean="0"/>
              <a:t>06/04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16AC64-D458-4E98-B918-6A6BA581F38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397350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45229-A2D6-4703-9BC7-7972F03D81E8}" type="datetimeFigureOut">
              <a:rPr lang="es-ES" smtClean="0"/>
              <a:t>06/04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16AC64-D458-4E98-B918-6A6BA581F38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752238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D45229-A2D6-4703-9BC7-7972F03D81E8}" type="datetimeFigureOut">
              <a:rPr lang="es-ES" smtClean="0"/>
              <a:t>06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16AC64-D458-4E98-B918-6A6BA581F38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182622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11808" y="1060093"/>
            <a:ext cx="3604307" cy="2499971"/>
          </a:xfrm>
          <a:prstGeom prst="rect">
            <a:avLst/>
          </a:prstGeom>
        </p:spPr>
      </p:pic>
      <p:sp>
        <p:nvSpPr>
          <p:cNvPr id="5" name="CuadroTexto 4">
            <a:extLst>
              <a:ext uri="{FF2B5EF4-FFF2-40B4-BE49-F238E27FC236}">
                <a16:creationId xmlns="" xmlns:a16="http://schemas.microsoft.com/office/drawing/2014/main" id="{607CD805-0785-45D2-ACE8-7316BC1B143B}"/>
              </a:ext>
            </a:extLst>
          </p:cNvPr>
          <p:cNvSpPr txBox="1"/>
          <p:nvPr/>
        </p:nvSpPr>
        <p:spPr>
          <a:xfrm>
            <a:off x="943294" y="3923578"/>
            <a:ext cx="474133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eritoneal cavity of a rainbow trout. The sampled adipose tissue is indicated with a black arrow. 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976222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>
            <a:extLst>
              <a:ext uri="{FF2B5EF4-FFF2-40B4-BE49-F238E27FC236}">
                <a16:creationId xmlns="" xmlns:a16="http://schemas.microsoft.com/office/drawing/2014/main" id="{AB1521BF-A949-46F3-8DF8-04A4EAC4FE7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14400" y="383906"/>
            <a:ext cx="4741334" cy="6273397"/>
          </a:xfrm>
          <a:prstGeom prst="rect">
            <a:avLst/>
          </a:prstGeom>
        </p:spPr>
      </p:pic>
      <p:sp>
        <p:nvSpPr>
          <p:cNvPr id="5" name="CuadroTexto 4">
            <a:extLst>
              <a:ext uri="{FF2B5EF4-FFF2-40B4-BE49-F238E27FC236}">
                <a16:creationId xmlns="" xmlns:a16="http://schemas.microsoft.com/office/drawing/2014/main" id="{607CD805-0785-45D2-ACE8-7316BC1B143B}"/>
              </a:ext>
            </a:extLst>
          </p:cNvPr>
          <p:cNvSpPr txBox="1"/>
          <p:nvPr/>
        </p:nvSpPr>
        <p:spPr>
          <a:xfrm>
            <a:off x="1058333" y="6874042"/>
            <a:ext cx="4741334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2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low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ytometry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analysis of MHC II expression levels and cell size in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IgM</a:t>
            </a:r>
            <a:r>
              <a:rPr lang="en-US" sz="12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 cell subpopulations in rainbow trout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eritoneal cavity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nd blood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low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ytometry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alysis of leukocytes from rainbow trout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eritoneal cavity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nd blood labelled with anti-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g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d anti-MHC II trout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mAb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A, B)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Graphs showing MFI values for FSC (left) and MFI values for MHC II (right) in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gM</a:t>
            </a:r>
            <a:r>
              <a:rPr lang="en-US" sz="12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gD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B cells compared to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gM</a:t>
            </a:r>
            <a:r>
              <a:rPr lang="en-US" sz="12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gD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 cells from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eritoneal cavity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d blood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mean + SD;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= 8). Asterisks denote significantly different values between groups as indicated (***p ≤ 0.005). 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248999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uadroTexto 4">
            <a:extLst>
              <a:ext uri="{FF2B5EF4-FFF2-40B4-BE49-F238E27FC236}">
                <a16:creationId xmlns="" xmlns:a16="http://schemas.microsoft.com/office/drawing/2014/main" id="{E1F0D300-35C5-4457-B6BB-FBB63C8F1473}"/>
              </a:ext>
            </a:extLst>
          </p:cNvPr>
          <p:cNvSpPr txBox="1"/>
          <p:nvPr/>
        </p:nvSpPr>
        <p:spPr>
          <a:xfrm>
            <a:off x="529390" y="7856924"/>
            <a:ext cx="5534526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3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low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ytometry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analysis of total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IgM</a:t>
            </a:r>
            <a:r>
              <a:rPr lang="en-US" sz="12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B cells in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intraperitoneally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immunized fish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Leukocytes isolated from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dipose tissue (AT), peritoneal cavity (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erC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, blood, spleen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ead kidney (HK)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ainbow trout immunized intraperitoneally with TNP-LPS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r mock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mmunized (control) were labeled with an anti-trout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g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mA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conjugated to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hycoerythri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PE) and analyzed by 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ﬂ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ow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ytometry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Representative dot plots showing the FSC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size) of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gM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B cells are included for each group and tissue at the three sampling times, 7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14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d 28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days post-immunization. The percentages of total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gM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B cells among cells in the lymphocyte gate are shown.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Imagen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8059" y="158496"/>
            <a:ext cx="5735857" cy="76702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0954125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>
            <a:extLst>
              <a:ext uri="{FF2B5EF4-FFF2-40B4-BE49-F238E27FC236}">
                <a16:creationId xmlns="" xmlns:a16="http://schemas.microsoft.com/office/drawing/2014/main" id="{2ACD174F-2DDD-4FC7-A322-7F0496312E3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620322"/>
            <a:ext cx="6858000" cy="2494407"/>
          </a:xfrm>
          <a:prstGeom prst="rect">
            <a:avLst/>
          </a:prstGeom>
        </p:spPr>
      </p:pic>
      <p:sp>
        <p:nvSpPr>
          <p:cNvPr id="6" name="CuadroTexto 5">
            <a:extLst>
              <a:ext uri="{FF2B5EF4-FFF2-40B4-BE49-F238E27FC236}">
                <a16:creationId xmlns="" xmlns:a16="http://schemas.microsoft.com/office/drawing/2014/main" id="{FFAFF6B3-A710-403A-BCA3-09E15BD454D2}"/>
              </a:ext>
            </a:extLst>
          </p:cNvPr>
          <p:cNvSpPr txBox="1"/>
          <p:nvPr/>
        </p:nvSpPr>
        <p:spPr>
          <a:xfrm>
            <a:off x="593557" y="1158657"/>
            <a:ext cx="5293896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able S1. Real time PCR primers used in this study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ene names, forward and reverse primer sequences are indicated.</a:t>
            </a:r>
            <a:endParaRPr lang="es-ES" sz="1200" dirty="0"/>
          </a:p>
        </p:txBody>
      </p:sp>
    </p:spTree>
    <p:extLst>
      <p:ext uri="{BB962C8B-B14F-4D97-AF65-F5344CB8AC3E}">
        <p14:creationId xmlns:p14="http://schemas.microsoft.com/office/powerpoint/2010/main" val="127539902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49</TotalTime>
  <Words>292</Words>
  <Application>Microsoft Office PowerPoint</Application>
  <PresentationFormat>A4 (210 x 297 mm)</PresentationFormat>
  <Paragraphs>4</Paragraphs>
  <Slides>4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Tema de Office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rosimsa@gmail.com</dc:creator>
  <cp:lastModifiedBy>Rocio Simon. Simon</cp:lastModifiedBy>
  <cp:revision>8</cp:revision>
  <dcterms:created xsi:type="dcterms:W3CDTF">2022-01-31T16:55:55Z</dcterms:created>
  <dcterms:modified xsi:type="dcterms:W3CDTF">2022-04-06T15:48:12Z</dcterms:modified>
</cp:coreProperties>
</file>